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56" r:id="rId2"/>
    <p:sldId id="257" r:id="rId3"/>
    <p:sldId id="263" r:id="rId4"/>
    <p:sldId id="267" r:id="rId5"/>
    <p:sldId id="284" r:id="rId6"/>
    <p:sldId id="271" r:id="rId7"/>
    <p:sldId id="277" r:id="rId8"/>
    <p:sldId id="290" r:id="rId9"/>
    <p:sldId id="291" r:id="rId10"/>
    <p:sldId id="272" r:id="rId11"/>
    <p:sldId id="281" r:id="rId12"/>
    <p:sldId id="283" r:id="rId13"/>
    <p:sldId id="265" r:id="rId14"/>
    <p:sldId id="275" r:id="rId15"/>
    <p:sldId id="274" r:id="rId16"/>
    <p:sldId id="285" r:id="rId17"/>
    <p:sldId id="286" r:id="rId18"/>
    <p:sldId id="287" r:id="rId19"/>
    <p:sldId id="288" r:id="rId20"/>
    <p:sldId id="278" r:id="rId21"/>
    <p:sldId id="289" r:id="rId2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77FC9"/>
    <a:srgbClr val="7271C9"/>
    <a:srgbClr val="4785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122"/>
    <p:restoredTop sz="94604"/>
  </p:normalViewPr>
  <p:slideViewPr>
    <p:cSldViewPr snapToGrid="0">
      <p:cViewPr varScale="1">
        <p:scale>
          <a:sx n="151" d="100"/>
          <a:sy n="151" d="100"/>
        </p:scale>
        <p:origin x="2464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C:\Users\yinfe\Desktop\desktop\Wnt\JAN1618-New%20PKF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83812088101314"/>
          <c:y val="5.2430373286672501E-2"/>
          <c:w val="0.70360785418721272"/>
          <c:h val="0.79425962379702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51</c:f>
              <c:strCache>
                <c:ptCount val="1"/>
                <c:pt idx="0">
                  <c:v>Co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39:$I$39</c:f>
                <c:numCache>
                  <c:formatCode>General</c:formatCode>
                  <c:ptCount val="3"/>
                  <c:pt idx="0">
                    <c:v>1.4294521094927725E-2</c:v>
                  </c:pt>
                  <c:pt idx="1">
                    <c:v>1.3650396819628858E-2</c:v>
                  </c:pt>
                  <c:pt idx="2">
                    <c:v>3.5118845842842497E-3</c:v>
                  </c:pt>
                </c:numCache>
              </c:numRef>
            </c:plus>
            <c:minus>
              <c:numRef>
                <c:f>Sheet1!$G$39:$I$39</c:f>
                <c:numCache>
                  <c:formatCode>General</c:formatCode>
                  <c:ptCount val="3"/>
                  <c:pt idx="0">
                    <c:v>1.4294521094927725E-2</c:v>
                  </c:pt>
                  <c:pt idx="1">
                    <c:v>1.3650396819628858E-2</c:v>
                  </c:pt>
                  <c:pt idx="2">
                    <c:v>3.5118845842842497E-3</c:v>
                  </c:pt>
                </c:numCache>
              </c:numRef>
            </c:minus>
          </c:errBars>
          <c:cat>
            <c:strRef>
              <c:f>Sheet1!$C$50:$E$50</c:f>
              <c:strCache>
                <c:ptCount val="3"/>
                <c:pt idx="0">
                  <c:v>MOLT3</c:v>
                </c:pt>
                <c:pt idx="1">
                  <c:v>TIB153</c:v>
                </c:pt>
                <c:pt idx="2">
                  <c:v>CUTLL1</c:v>
                </c:pt>
              </c:strCache>
            </c:strRef>
          </c:cat>
          <c:val>
            <c:numRef>
              <c:f>Sheet1!$C$51:$E$51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DD-D847-AAD0-BC5F7BD07733}"/>
            </c:ext>
          </c:extLst>
        </c:ser>
        <c:ser>
          <c:idx val="1"/>
          <c:order val="1"/>
          <c:tx>
            <c:strRef>
              <c:f>Sheet1!$B$52</c:f>
              <c:strCache>
                <c:ptCount val="1"/>
                <c:pt idx="0">
                  <c:v>0.25µM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40:$I$40</c:f>
                <c:numCache>
                  <c:formatCode>General</c:formatCode>
                  <c:ptCount val="3"/>
                  <c:pt idx="0">
                    <c:v>9.073771725877474E-3</c:v>
                  </c:pt>
                  <c:pt idx="1">
                    <c:v>1.1372481406154664E-2</c:v>
                  </c:pt>
                  <c:pt idx="2">
                    <c:v>1.8583146486355593E-2</c:v>
                  </c:pt>
                </c:numCache>
              </c:numRef>
            </c:plus>
            <c:minus>
              <c:numRef>
                <c:f>Sheet1!$G$40:$I$40</c:f>
                <c:numCache>
                  <c:formatCode>General</c:formatCode>
                  <c:ptCount val="3"/>
                  <c:pt idx="0">
                    <c:v>9.073771725877474E-3</c:v>
                  </c:pt>
                  <c:pt idx="1">
                    <c:v>1.1372481406154664E-2</c:v>
                  </c:pt>
                  <c:pt idx="2">
                    <c:v>1.8583146486355593E-2</c:v>
                  </c:pt>
                </c:numCache>
              </c:numRef>
            </c:minus>
          </c:errBars>
          <c:cat>
            <c:strRef>
              <c:f>Sheet1!$C$50:$E$50</c:f>
              <c:strCache>
                <c:ptCount val="3"/>
                <c:pt idx="0">
                  <c:v>MOLT3</c:v>
                </c:pt>
                <c:pt idx="1">
                  <c:v>TIB153</c:v>
                </c:pt>
                <c:pt idx="2">
                  <c:v>CUTLL1</c:v>
                </c:pt>
              </c:strCache>
            </c:strRef>
          </c:cat>
          <c:val>
            <c:numRef>
              <c:f>Sheet1!$C$52:$E$52</c:f>
              <c:numCache>
                <c:formatCode>General</c:formatCode>
                <c:ptCount val="3"/>
                <c:pt idx="0">
                  <c:v>0.95616717635066251</c:v>
                </c:pt>
                <c:pt idx="1">
                  <c:v>0.81682734443470628</c:v>
                </c:pt>
                <c:pt idx="2">
                  <c:v>0.892818863879957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DD-D847-AAD0-BC5F7BD07733}"/>
            </c:ext>
          </c:extLst>
        </c:ser>
        <c:ser>
          <c:idx val="2"/>
          <c:order val="2"/>
          <c:tx>
            <c:strRef>
              <c:f>Sheet1!$B$53</c:f>
              <c:strCache>
                <c:ptCount val="1"/>
                <c:pt idx="0">
                  <c:v>0.5µM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41:$I$41</c:f>
                <c:numCache>
                  <c:formatCode>General</c:formatCode>
                  <c:ptCount val="3"/>
                  <c:pt idx="0">
                    <c:v>7.3711147958319999E-3</c:v>
                  </c:pt>
                  <c:pt idx="1">
                    <c:v>1.4798648586948992E-2</c:v>
                  </c:pt>
                  <c:pt idx="2">
                    <c:v>5.1316014394468881E-3</c:v>
                  </c:pt>
                </c:numCache>
              </c:numRef>
            </c:plus>
            <c:minus>
              <c:numRef>
                <c:f>Sheet1!$G$41:$I$41</c:f>
                <c:numCache>
                  <c:formatCode>General</c:formatCode>
                  <c:ptCount val="3"/>
                  <c:pt idx="0">
                    <c:v>7.3711147958319999E-3</c:v>
                  </c:pt>
                  <c:pt idx="1">
                    <c:v>1.4798648586948992E-2</c:v>
                  </c:pt>
                  <c:pt idx="2">
                    <c:v>5.1316014394468881E-3</c:v>
                  </c:pt>
                </c:numCache>
              </c:numRef>
            </c:minus>
          </c:errBars>
          <c:cat>
            <c:strRef>
              <c:f>Sheet1!$C$50:$E$50</c:f>
              <c:strCache>
                <c:ptCount val="3"/>
                <c:pt idx="0">
                  <c:v>MOLT3</c:v>
                </c:pt>
                <c:pt idx="1">
                  <c:v>TIB153</c:v>
                </c:pt>
                <c:pt idx="2">
                  <c:v>CUTLL1</c:v>
                </c:pt>
              </c:strCache>
            </c:strRef>
          </c:cat>
          <c:val>
            <c:numRef>
              <c:f>Sheet1!$C$53:$E$53</c:f>
              <c:numCache>
                <c:formatCode>General</c:formatCode>
                <c:ptCount val="3"/>
                <c:pt idx="0">
                  <c:v>0.80326197757390416</c:v>
                </c:pt>
                <c:pt idx="1">
                  <c:v>0.67221735319894826</c:v>
                </c:pt>
                <c:pt idx="2">
                  <c:v>0.756698821007502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DDD-D847-AAD0-BC5F7BD07733}"/>
            </c:ext>
          </c:extLst>
        </c:ser>
        <c:ser>
          <c:idx val="3"/>
          <c:order val="3"/>
          <c:tx>
            <c:strRef>
              <c:f>Sheet1!$B$54</c:f>
              <c:strCache>
                <c:ptCount val="1"/>
                <c:pt idx="0">
                  <c:v>1µM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47:$I$47</c:f>
                <c:numCache>
                  <c:formatCode>General</c:formatCode>
                  <c:ptCount val="3"/>
                  <c:pt idx="0">
                    <c:v>7.234178138070241E-3</c:v>
                  </c:pt>
                  <c:pt idx="1">
                    <c:v>1.2662279942148398E-2</c:v>
                  </c:pt>
                  <c:pt idx="2">
                    <c:v>9.2915732431775779E-3</c:v>
                  </c:pt>
                </c:numCache>
              </c:numRef>
            </c:plus>
            <c:minus>
              <c:numRef>
                <c:f>Sheet1!$G$47:$I$47</c:f>
                <c:numCache>
                  <c:formatCode>General</c:formatCode>
                  <c:ptCount val="3"/>
                  <c:pt idx="0">
                    <c:v>7.234178138070241E-3</c:v>
                  </c:pt>
                  <c:pt idx="1">
                    <c:v>1.2662279942148398E-2</c:v>
                  </c:pt>
                  <c:pt idx="2">
                    <c:v>9.2915732431775779E-3</c:v>
                  </c:pt>
                </c:numCache>
              </c:numRef>
            </c:minus>
          </c:errBars>
          <c:cat>
            <c:strRef>
              <c:f>Sheet1!$C$50:$E$50</c:f>
              <c:strCache>
                <c:ptCount val="3"/>
                <c:pt idx="0">
                  <c:v>MOLT3</c:v>
                </c:pt>
                <c:pt idx="1">
                  <c:v>TIB153</c:v>
                </c:pt>
                <c:pt idx="2">
                  <c:v>CUTLL1</c:v>
                </c:pt>
              </c:strCache>
            </c:strRef>
          </c:cat>
          <c:val>
            <c:numRef>
              <c:f>Sheet1!$C$54:$E$54</c:f>
              <c:numCache>
                <c:formatCode>General</c:formatCode>
                <c:ptCount val="3"/>
                <c:pt idx="0">
                  <c:v>0.47298674821610609</c:v>
                </c:pt>
                <c:pt idx="1">
                  <c:v>0.36021034180543382</c:v>
                </c:pt>
                <c:pt idx="2">
                  <c:v>0.420150053590568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DDD-D847-AAD0-BC5F7BD07733}"/>
            </c:ext>
          </c:extLst>
        </c:ser>
        <c:ser>
          <c:idx val="4"/>
          <c:order val="4"/>
          <c:tx>
            <c:strRef>
              <c:f>Sheet1!$B$55</c:f>
              <c:strCache>
                <c:ptCount val="1"/>
                <c:pt idx="0">
                  <c:v>2µM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48:$I$48</c:f>
                <c:numCache>
                  <c:formatCode>General</c:formatCode>
                  <c:ptCount val="3"/>
                  <c:pt idx="0">
                    <c:v>1.1357816691600537E-2</c:v>
                  </c:pt>
                  <c:pt idx="1">
                    <c:v>2.1221058723195938E-2</c:v>
                  </c:pt>
                  <c:pt idx="2">
                    <c:v>8.3864970836060905E-3</c:v>
                  </c:pt>
                </c:numCache>
              </c:numRef>
            </c:plus>
            <c:minus>
              <c:numRef>
                <c:f>Sheet1!$G$48:$I$48</c:f>
                <c:numCache>
                  <c:formatCode>General</c:formatCode>
                  <c:ptCount val="3"/>
                  <c:pt idx="0">
                    <c:v>1.1357816691600537E-2</c:v>
                  </c:pt>
                  <c:pt idx="1">
                    <c:v>2.1221058723195938E-2</c:v>
                  </c:pt>
                  <c:pt idx="2">
                    <c:v>8.3864970836060905E-3</c:v>
                  </c:pt>
                </c:numCache>
              </c:numRef>
            </c:minus>
          </c:errBars>
          <c:cat>
            <c:strRef>
              <c:f>Sheet1!$C$50:$E$50</c:f>
              <c:strCache>
                <c:ptCount val="3"/>
                <c:pt idx="0">
                  <c:v>MOLT3</c:v>
                </c:pt>
                <c:pt idx="1">
                  <c:v>TIB153</c:v>
                </c:pt>
                <c:pt idx="2">
                  <c:v>CUTLL1</c:v>
                </c:pt>
              </c:strCache>
            </c:strRef>
          </c:cat>
          <c:val>
            <c:numRef>
              <c:f>Sheet1!$C$55:$E$55</c:f>
              <c:numCache>
                <c:formatCode>General</c:formatCode>
                <c:ptCount val="3"/>
                <c:pt idx="0">
                  <c:v>0.12538226299694191</c:v>
                </c:pt>
                <c:pt idx="1">
                  <c:v>2.5416301489921144E-2</c:v>
                </c:pt>
                <c:pt idx="2">
                  <c:v>8.252947481243298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DDD-D847-AAD0-BC5F7BD077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4763392"/>
        <c:axId val="64764928"/>
      </c:barChart>
      <c:catAx>
        <c:axId val="647633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4764928"/>
        <c:crosses val="autoZero"/>
        <c:auto val="1"/>
        <c:lblAlgn val="ctr"/>
        <c:lblOffset val="100"/>
        <c:noMultiLvlLbl val="0"/>
      </c:catAx>
      <c:valAx>
        <c:axId val="64764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476339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11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14583</cdr:y>
    </cdr:from>
    <cdr:to>
      <cdr:x>0.06958</cdr:x>
      <cdr:y>0.66319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542925" y="942975"/>
          <a:ext cx="1419225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itchFamily="34" charset="0"/>
              <a:cs typeface="Arial" pitchFamily="34" charset="0"/>
            </a:rPr>
            <a:t>Cell</a:t>
          </a:r>
          <a:r>
            <a:rPr lang="en-US" sz="1100" baseline="0" dirty="0">
              <a:latin typeface="Arial" pitchFamily="34" charset="0"/>
              <a:cs typeface="Arial" pitchFamily="34" charset="0"/>
            </a:rPr>
            <a:t> viability</a:t>
          </a:r>
          <a:endParaRPr lang="en-US" sz="11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6A5F29-4984-8D43-B7F8-D704A84D527B}" type="datetimeFigureOut">
              <a:rPr lang="en-US" smtClean="0"/>
              <a:t>8/3/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2E63EC-A105-3D4F-A4A9-63F897F6B53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644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2E63EC-A105-3D4F-A4A9-63F897F6B536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13775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30350"/>
            <a:ext cx="7772400" cy="1470025"/>
          </a:xfrm>
        </p:spPr>
        <p:txBody>
          <a:bodyPr/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Supplemental Material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286124"/>
            <a:ext cx="6400800" cy="2161087"/>
          </a:xfrm>
        </p:spPr>
        <p:txBody>
          <a:bodyPr>
            <a:normAutofit lnSpcReduction="10000"/>
          </a:bodyPr>
          <a:lstStyle/>
          <a:p>
            <a:r>
              <a:rPr lang="en-US" sz="2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Yinfei Tan et al., Wnt Signaling Mediates Oncogenic Synergy Between Akt and Dlx5 in T-Cell Lymphomagenesis by Enhancing Cholesterol Synthesis</a:t>
            </a:r>
          </a:p>
          <a:p>
            <a:endParaRPr 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38400" y="1752600"/>
            <a:ext cx="4194464" cy="25734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Rectangle 5"/>
          <p:cNvSpPr/>
          <p:nvPr/>
        </p:nvSpPr>
        <p:spPr>
          <a:xfrm>
            <a:off x="1473200" y="4940300"/>
            <a:ext cx="62103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itchFamily="34" charset="0"/>
              </a:rPr>
              <a:t>Supplementary Fig. S5A.  β-catenin complex weakly binds to the promoter/gene of the cholesterol synthesis pathway gene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Ncoa2</a:t>
            </a:r>
            <a:r>
              <a:rPr lang="en-US" sz="1600" b="1" dirty="0">
                <a:latin typeface="Arial" panose="020B0604020202020204" pitchFamily="34" charset="0"/>
                <a:cs typeface="Arial" pitchFamily="34" charset="0"/>
              </a:rPr>
              <a:t>.  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yinfe\Desktop\desktop\Wnt\manuscript 4\Joe-version\mouse-5-days.tif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77996" y="2336368"/>
            <a:ext cx="4794504" cy="1652016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2122338" y="4399055"/>
            <a:ext cx="5040462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Supplementary Fig. S5B.  Immunoblotting demonstrating that RO 48-8041 and simvastatin cause apoptosis in T cell lymphoma cells from two </a:t>
            </a:r>
            <a:r>
              <a:rPr lang="en-US" sz="1400" b="1" i="1" dirty="0">
                <a:latin typeface="Arial" panose="020B0604020202020204" pitchFamily="34" charset="0"/>
                <a:cs typeface="Arial" pitchFamily="34" charset="0"/>
              </a:rPr>
              <a:t>Lck-Dlx5;Lck-MyrAkt2 </a:t>
            </a:r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mice (DP242 and DP352) after 3 days of treatment. </a:t>
            </a:r>
            <a:r>
              <a:rPr lang="en-US" sz="1400" dirty="0">
                <a:latin typeface="Arial" panose="020B0604020202020204" pitchFamily="34" charset="0"/>
                <a:cs typeface="Arial" pitchFamily="34" charset="0"/>
              </a:rPr>
              <a:t>Apoptosis is observed at a concentration as low as 5 µM after 3 d of treatment.  Higher concentrations induced gross degradation of cellular proteins by day 3, as reflected by decreased Gapdh levels.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147825" y="4674228"/>
            <a:ext cx="6858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Supplementary Fig. S5C,D. The combination of the cholesterol inhibitor simvastatin with the mTOR inhibitor RAD001 has a cooperative effect in reducing viability of T cell lymphoma cells from </a:t>
            </a:r>
            <a:r>
              <a:rPr lang="en-US" sz="1400" b="1" i="1" dirty="0">
                <a:latin typeface="Arial" panose="020B0604020202020204" pitchFamily="34" charset="0"/>
                <a:cs typeface="Arial" pitchFamily="34" charset="0"/>
              </a:rPr>
              <a:t>Lck-Dlx5;Lck-MyrAkt2 </a:t>
            </a:r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mice. </a:t>
            </a:r>
            <a:r>
              <a:rPr lang="en-US" sz="1400" dirty="0">
                <a:latin typeface="Arial" panose="020B0604020202020204" pitchFamily="34" charset="0"/>
                <a:cs typeface="Arial" pitchFamily="34" charset="0"/>
              </a:rPr>
              <a:t>Cells were treated with a combination of RAD001 and simvastatin at the indicated concentrations for 3 days. Cell viability were measured by MTS assay (</a:t>
            </a:r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C</a:t>
            </a:r>
            <a:r>
              <a:rPr lang="en-US" sz="1400" dirty="0">
                <a:latin typeface="Arial" panose="020B0604020202020204" pitchFamily="34" charset="0"/>
                <a:cs typeface="Arial" pitchFamily="34" charset="0"/>
              </a:rPr>
              <a:t>).  Activation of caspase 3 was determined by immunoblotting (</a:t>
            </a:r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D</a:t>
            </a:r>
            <a:r>
              <a:rPr lang="en-US" sz="1400" dirty="0">
                <a:latin typeface="Arial" panose="020B0604020202020204" pitchFamily="34" charset="0"/>
                <a:cs typeface="Arial" pitchFamily="34" charset="0"/>
              </a:rPr>
              <a:t>).</a:t>
            </a:r>
          </a:p>
        </p:txBody>
      </p:sp>
      <p:pic>
        <p:nvPicPr>
          <p:cNvPr id="1027" name="Picture 3" descr="C:\Users\yinfe\Desktop\desktop\Wnt\manuscript 4\Joe-version\mouse-comb-16-24H.tif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47824" y="1874127"/>
            <a:ext cx="6858000" cy="2389632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4085120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CDD271D3-F1B1-4D47-BD97-BB7FF6B547AB}"/>
              </a:ext>
            </a:extLst>
          </p:cNvPr>
          <p:cNvSpPr/>
          <p:nvPr/>
        </p:nvSpPr>
        <p:spPr>
          <a:xfrm>
            <a:off x="931280" y="4716521"/>
            <a:ext cx="728144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itchFamily="34" charset="0"/>
                <a:cs typeface="Arial" pitchFamily="34" charset="0"/>
              </a:rPr>
              <a:t>Supplementary Fig. S6.  Treatment of human T-ALL cell lines with the β-catenin inhibitor PFK118-310 results in reduced cell viability in a dose-dependent manner.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MOLT3, TIB153 and CUTLL1 were treated with PKF118-310 at the indicated concentrations, and MTS assay was performed 24 h after treatment.</a:t>
            </a:r>
          </a:p>
        </p:txBody>
      </p:sp>
      <p:graphicFrame>
        <p:nvGraphicFramePr>
          <p:cNvPr id="7" name="Content Placeholder 5">
            <a:extLst>
              <a:ext uri="{FF2B5EF4-FFF2-40B4-BE49-F238E27FC236}">
                <a16:creationId xmlns:a16="http://schemas.microsoft.com/office/drawing/2014/main" id="{F3C0A7E1-EF78-854E-9355-FD03D0CA9C4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82104032"/>
              </p:ext>
            </p:extLst>
          </p:nvPr>
        </p:nvGraphicFramePr>
        <p:xfrm>
          <a:off x="2018898" y="1046747"/>
          <a:ext cx="5122245" cy="28915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4B93143-C5FA-D64C-A36C-9BD788CA84DF}"/>
              </a:ext>
            </a:extLst>
          </p:cNvPr>
          <p:cNvSpPr/>
          <p:nvPr/>
        </p:nvSpPr>
        <p:spPr>
          <a:xfrm>
            <a:off x="812800" y="4901698"/>
            <a:ext cx="75184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itchFamily="34" charset="0"/>
                <a:cs typeface="Arial" pitchFamily="34" charset="0"/>
              </a:rPr>
              <a:t>Supplementary Fig. S7A.  Differentially expressed genes in two human T-ALL cell lines following </a:t>
            </a:r>
            <a:r>
              <a:rPr lang="el-GR" b="1" dirty="0">
                <a:latin typeface="Arial" pitchFamily="34" charset="0"/>
                <a:cs typeface="Arial" pitchFamily="34" charset="0"/>
              </a:rPr>
              <a:t>β-</a:t>
            </a:r>
            <a:r>
              <a:rPr lang="en-US" b="1" dirty="0">
                <a:latin typeface="Arial" pitchFamily="34" charset="0"/>
                <a:cs typeface="Arial" pitchFamily="34" charset="0"/>
              </a:rPr>
              <a:t>catenin inhibition. </a:t>
            </a:r>
            <a:r>
              <a:rPr lang="en-US" dirty="0">
                <a:latin typeface="Arial" pitchFamily="34" charset="0"/>
                <a:cs typeface="Arial" pitchFamily="34" charset="0"/>
              </a:rPr>
              <a:t>Venn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diagram</a:t>
            </a:r>
            <a:r>
              <a:rPr lang="en-US" dirty="0">
                <a:latin typeface="Arial" pitchFamily="34" charset="0"/>
                <a:cs typeface="Arial" pitchFamily="34" charset="0"/>
              </a:rPr>
              <a:t> depicting commonly up- or down-regulated genes in these human T-ALL cell lines TIB153 and CUTLL1 treated with PFK118-310 and subjected to RNA-seq analysis.</a:t>
            </a:r>
          </a:p>
        </p:txBody>
      </p:sp>
      <p:pic>
        <p:nvPicPr>
          <p:cNvPr id="7" name="Picture 2" descr="C:\Users\yinfe\Desktop\desktop\Wnt\manuscript 4\suppl.fig.7a.tif">
            <a:extLst>
              <a:ext uri="{FF2B5EF4-FFF2-40B4-BE49-F238E27FC236}">
                <a16:creationId xmlns:a16="http://schemas.microsoft.com/office/drawing/2014/main" id="{6A3BABDD-47EB-CF4E-ABF5-D7F094C3C466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756653" y="1640305"/>
            <a:ext cx="7637228" cy="283709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2679700" y="462248"/>
            <a:ext cx="3797300" cy="49781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6C7510B-B3F7-8742-A88B-52CC5013B4ED}"/>
              </a:ext>
            </a:extLst>
          </p:cNvPr>
          <p:cNvSpPr/>
          <p:nvPr/>
        </p:nvSpPr>
        <p:spPr>
          <a:xfrm>
            <a:off x="1554875" y="5715000"/>
            <a:ext cx="653034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itchFamily="34" charset="0"/>
                <a:cs typeface="Arial" pitchFamily="34" charset="0"/>
              </a:rPr>
              <a:t>Supplementary Fig. S7B.  Reactome analysis depicting the pathways most significantly altered in human T-ALL cell lines CUTLL1 and TIB153 by β-catenin/Wnt inhibition with PKF118-310.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 descr="C:\Users\yinfe\Desktop\desktop\Wnt\manuscript 4\SupplFig8A.tif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1774788" y="251460"/>
            <a:ext cx="5608992" cy="4953000"/>
          </a:xfrm>
          <a:prstGeom prst="rect">
            <a:avLst/>
          </a:prstGeom>
          <a:noFill/>
        </p:spPr>
      </p:pic>
      <p:sp>
        <p:nvSpPr>
          <p:cNvPr id="6" name="Rectangle 5"/>
          <p:cNvSpPr/>
          <p:nvPr/>
        </p:nvSpPr>
        <p:spPr>
          <a:xfrm>
            <a:off x="350184" y="5288280"/>
            <a:ext cx="84582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Supplementary Fig. S8A.  Correlation between WNT activity and expression of homeobox genes and stem cell-related genes in 20 human T-ALLs. 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Heatmap of 20 T-ALLs (depicted along X-axis) demonstrating that the expression of WNT/LEF/TCF activity markers such as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LEF1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TCF3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TCF7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(near bottom at right side) are negatively correlated with those of homeobox genes such as some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HOX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DLX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family members and stem cell-related genes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GLI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NOTCH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(and targets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HEY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HEX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395443252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C:\Users\yinfe\Desktop\desktop\Wnt\manuscript 4\supplFig8B.tif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1767654" y="414619"/>
            <a:ext cx="5617651" cy="4667853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271180" y="5181600"/>
            <a:ext cx="86106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Supplementary Fig. S8B.  Correlation between WNT activity and expression of key protooncogenes in 20 human T-ALLs. 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Heatmap showing correlation of WNT pathway activation with protooncogenes and tumor suppressor genes.  With regard to genes implicated in cell proliferation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LEF1/TCF7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(upper right)  is positively correlated with expression of genes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PAK2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MAP2K2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STAT5A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PIK3R3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PIK3C2B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CCND3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but negatively correlated with genes such as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TLR3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IGF1/2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EGFR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PAK3/5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15595304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1905000" y="900953"/>
            <a:ext cx="5334000" cy="44672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Rectangle 5"/>
          <p:cNvSpPr/>
          <p:nvPr/>
        </p:nvSpPr>
        <p:spPr>
          <a:xfrm>
            <a:off x="876300" y="5516635"/>
            <a:ext cx="73914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Supplementary Fig. S8C.  Correlation between WNT pathway activation and expression of various invasion- and metastasis-related genes in 20 human T-ALLs.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Heatmap showing negative correlation between expression of </a:t>
            </a:r>
            <a:r>
              <a:rPr lang="en-US" sz="1400" i="1" dirty="0">
                <a:latin typeface="Arial" panose="020B0604020202020204" pitchFamily="34" charset="0"/>
                <a:cs typeface="Arial" pitchFamily="34" charset="0"/>
              </a:rPr>
              <a:t>LEF1/TCF7</a:t>
            </a:r>
            <a:r>
              <a:rPr lang="en-US" sz="1400" dirty="0">
                <a:latin typeface="Arial" panose="020B0604020202020204" pitchFamily="34" charset="0"/>
                <a:cs typeface="Arial" pitchFamily="34" charset="0"/>
              </a:rPr>
              <a:t> (lower right) and expression of invasion/metastasis genes such as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MM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XC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SERPI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family genes.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5900" y="453637"/>
            <a:ext cx="838200" cy="715962"/>
          </a:xfrm>
        </p:spPr>
        <p:txBody>
          <a:bodyPr>
            <a:norm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87970884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1896937" y="513223"/>
            <a:ext cx="5364301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877189" y="5245129"/>
            <a:ext cx="7391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itchFamily="34" charset="0"/>
                <a:cs typeface="Arial" pitchFamily="34" charset="0"/>
              </a:rPr>
              <a:t>Supplementary Fig. S8D.  Heatmap depicting negative correlation between WNT activity and expression of some stem cell maintenance and epigenetic modifier genes in 20 human T-ALLs.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Expression of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LEF/TCF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(lower right) were negatively correlated with expression of certain stem cell maintenance genes such as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NANOG, SOX2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POU5F1,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but positively correlated with the expression of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MYC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epigenetic modifier genes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HDAC1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BRD3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15937" y="307280"/>
            <a:ext cx="762000" cy="639762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57720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52464" y="5257800"/>
            <a:ext cx="7848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itchFamily="34" charset="0"/>
                <a:cs typeface="Arial" pitchFamily="34" charset="0"/>
              </a:rPr>
              <a:t>Supplementary Fig. S1A.   Histopathology of disseminated T-cell lymphoma from </a:t>
            </a:r>
            <a:r>
              <a:rPr lang="en-US" sz="1600" b="1" i="1" dirty="0">
                <a:latin typeface="Arial" pitchFamily="34" charset="0"/>
                <a:cs typeface="Arial" pitchFamily="34" charset="0"/>
              </a:rPr>
              <a:t>Lck-Dlx5;Akt2 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mouse.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H&amp;E staining of lymphoma in thymus, lung, liver, kidney, spleen and bone marrow of same mouse.  White bars, 100 microns.</a:t>
            </a:r>
          </a:p>
        </p:txBody>
      </p:sp>
      <p:pic>
        <p:nvPicPr>
          <p:cNvPr id="3075" name="Picture 3" descr="C:\Users\yinfe\Desktop\desktop\Wnt\manuscript 4\SF1.DP-HE2.jpg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" y="1371600"/>
            <a:ext cx="8229600" cy="3475623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84307" y="1045161"/>
            <a:ext cx="5798535" cy="754062"/>
          </a:xfrm>
        </p:spPr>
        <p:txBody>
          <a:bodyPr>
            <a:normAutofit fontScale="90000"/>
          </a:bodyPr>
          <a:lstStyle/>
          <a:p>
            <a:pPr algn="just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 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Karyotypic analysis of thymic lymphomas from </a:t>
            </a:r>
            <a:r>
              <a:rPr lang="en-US" sz="2000" i="1" dirty="0">
                <a:latin typeface="Arial" panose="020B0604020202020204" pitchFamily="34" charset="0"/>
                <a:cs typeface="Arial" panose="020B0604020202020204" pitchFamily="34" charset="0"/>
              </a:rPr>
              <a:t>Lck-Dlx5;Lck-MyrAkt2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1817370" y="1920081"/>
          <a:ext cx="5509260" cy="3886200"/>
        </p:xfrm>
        <a:graphic>
          <a:graphicData uri="http://schemas.openxmlformats.org/drawingml/2006/table">
            <a:tbl>
              <a:tblPr/>
              <a:tblGrid>
                <a:gridCol w="22002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0871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002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530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3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Mouse ID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3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ounder Line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3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Karyotypic Abnormalities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37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25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63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+15,+16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56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47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(Normal karyotype)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23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63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+15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89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63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+15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20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63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+15 / +15,+del(10)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60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47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del(2),+15,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87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86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(Normal karyotype)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23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63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+15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924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265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F47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218440" marR="0"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(Normal karyotype)</a:t>
                      </a:r>
                      <a:endParaRPr lang="en-US" sz="1200" dirty="0">
                        <a:solidFill>
                          <a:srgbClr val="000000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26A80C-367D-7649-AF36-D2D84FB4D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Full List of Author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4AFAF0-2CF0-2942-81C7-728ED22286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5780" y="1592581"/>
            <a:ext cx="8092440" cy="4533900"/>
          </a:xfrm>
        </p:spPr>
        <p:txBody>
          <a:bodyPr>
            <a:normAutofit/>
          </a:bodyPr>
          <a:lstStyle/>
          <a:p>
            <a:pPr>
              <a:spcBef>
                <a:spcPts val="0"/>
              </a:spcBef>
              <a:spcAft>
                <a:spcPts val="180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Yinfei Tan, Ph.D.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ancer Biology Program and Genomics Facility, Fox Chase Cancer Center, Philadelphia, PA 19111, USA;</a:t>
            </a:r>
          </a:p>
          <a:p>
            <a:pPr>
              <a:spcBef>
                <a:spcPts val="0"/>
              </a:spcBef>
              <a:spcAft>
                <a:spcPts val="180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leonora Sementino, M.S.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ancer Biology Program, Fox Chase Cancer Center, Philadelphia, PA 19111, USA;</a:t>
            </a:r>
          </a:p>
          <a:p>
            <a:pPr>
              <a:spcBef>
                <a:spcPts val="0"/>
              </a:spcBef>
              <a:spcAft>
                <a:spcPts val="180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Zemin Liu, M.D.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Genomics Facility, Fox Chase Cancer Center, Philadelphia, PA 19111, USA;</a:t>
            </a:r>
          </a:p>
          <a:p>
            <a:pPr>
              <a:spcBef>
                <a:spcPts val="0"/>
              </a:spcBef>
              <a:spcAft>
                <a:spcPts val="180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Kathy Q. Cai, M.D., Ph.D.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istopathology Facility, Fox Chase Cancer Center, Philadelphia, PA 19111, USA;</a:t>
            </a:r>
          </a:p>
          <a:p>
            <a:pPr>
              <a:spcBef>
                <a:spcPts val="0"/>
              </a:spcBef>
              <a:spcAft>
                <a:spcPts val="180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Joseph R. Testa, Ph.D., FACMG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ancer Biology Program and Genomics Facility, Fox Chase Cancer Center, Philadelphia, PA 19111, USA.</a:t>
            </a:r>
          </a:p>
        </p:txBody>
      </p:sp>
    </p:spTree>
    <p:extLst>
      <p:ext uri="{BB962C8B-B14F-4D97-AF65-F5344CB8AC3E}">
        <p14:creationId xmlns:p14="http://schemas.microsoft.com/office/powerpoint/2010/main" val="33042697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14440" y="5257800"/>
            <a:ext cx="668655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itchFamily="34" charset="0"/>
                <a:cs typeface="Arial" pitchFamily="34" charset="0"/>
              </a:rPr>
              <a:t>Supplementary Fig. S1B.   Lymphoma cells from </a:t>
            </a:r>
            <a:r>
              <a:rPr lang="en-US" sz="1600" b="1" i="1" dirty="0">
                <a:latin typeface="Arial" pitchFamily="34" charset="0"/>
                <a:cs typeface="Arial" pitchFamily="34" charset="0"/>
              </a:rPr>
              <a:t>Lck-Dlx5;Akt2 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mice are CD4;CD8 double-positive. 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Lymphoma cell lines DP240 and DP242 were stained with CD4-FITC and CD8-PE antibodies and analyzed by FACS. 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12FF85EA-19D8-174E-B440-18FB395D0C71}"/>
              </a:ext>
            </a:extLst>
          </p:cNvPr>
          <p:cNvGrpSpPr/>
          <p:nvPr/>
        </p:nvGrpSpPr>
        <p:grpSpPr>
          <a:xfrm>
            <a:off x="1564640" y="1248936"/>
            <a:ext cx="6024880" cy="3691354"/>
            <a:chOff x="1564640" y="1248936"/>
            <a:chExt cx="6024880" cy="3691354"/>
          </a:xfrm>
        </p:grpSpPr>
        <p:sp>
          <p:nvSpPr>
            <p:cNvPr id="5" name="TextBox 4"/>
            <p:cNvSpPr txBox="1"/>
            <p:nvPr/>
          </p:nvSpPr>
          <p:spPr>
            <a:xfrm>
              <a:off x="3124199" y="4601736"/>
              <a:ext cx="33909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itchFamily="34" charset="0"/>
                  <a:cs typeface="Arial" pitchFamily="34" charset="0"/>
                </a:rPr>
                <a:t>DP                                            DP</a:t>
              </a:r>
            </a:p>
          </p:txBody>
        </p:sp>
        <p:pic>
          <p:nvPicPr>
            <p:cNvPr id="7" name="Picture 3" descr="C:\Users\ytan\Desktop\Wnt\manuscript 4\SF2.Lck T cell CD4-8b.TIFF">
              <a:extLst>
                <a:ext uri="{FF2B5EF4-FFF2-40B4-BE49-F238E27FC236}">
                  <a16:creationId xmlns:a16="http://schemas.microsoft.com/office/drawing/2014/main" id="{9D006244-CE8E-164E-A1C3-49AF27DC982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/>
            <a:srcRect l="9630"/>
            <a:stretch/>
          </p:blipFill>
          <p:spPr bwMode="auto">
            <a:xfrm>
              <a:off x="1564640" y="1248936"/>
              <a:ext cx="6024880" cy="3352800"/>
            </a:xfrm>
            <a:prstGeom prst="rect">
              <a:avLst/>
            </a:prstGeom>
            <a:noFill/>
          </p:spPr>
        </p:pic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7353" y="4343400"/>
            <a:ext cx="762000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itchFamily="34" charset="0"/>
                <a:cs typeface="Arial" pitchFamily="34" charset="0"/>
              </a:rPr>
              <a:t>Supplementary Fig. S2.   β-catenin is not transcriptionally up regulated among various mouse lymphoma samples tested.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Figure depicts qPCR on lymphoma samples from WT, </a:t>
            </a:r>
            <a:r>
              <a:rPr lang="en-US" sz="1600" i="1" dirty="0">
                <a:latin typeface="Arial" pitchFamily="34" charset="0"/>
                <a:cs typeface="Arial" pitchFamily="34" charset="0"/>
              </a:rPr>
              <a:t>Lck-Dlx5, Lck-MyrAkt2,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and</a:t>
            </a:r>
            <a:r>
              <a:rPr lang="en-US" sz="1600" i="1" dirty="0">
                <a:latin typeface="Arial" pitchFamily="34" charset="0"/>
                <a:cs typeface="Arial" pitchFamily="34" charset="0"/>
              </a:rPr>
              <a:t> Lck-Dlx5;Lck-MyrAkt2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mice, with no consistent difference in </a:t>
            </a:r>
            <a:r>
              <a:rPr lang="en-US" sz="1600" i="1" dirty="0">
                <a:latin typeface="Arial" pitchFamily="34" charset="0"/>
                <a:cs typeface="Arial" pitchFamily="34" charset="0"/>
              </a:rPr>
              <a:t>Ctnnb1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 mRNA levels among the various mouse genotype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48995B7-97F4-A849-AFEE-2678A39C2C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9673" y="1352366"/>
            <a:ext cx="5495360" cy="2649364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120306" y="5218739"/>
            <a:ext cx="690510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itchFamily="34" charset="0"/>
                <a:cs typeface="Arial" pitchFamily="34" charset="0"/>
              </a:rPr>
              <a:t>Supplementary Fig. S3.  Flow cytometric analysis of mouse lymphoma cells following </a:t>
            </a:r>
            <a:r>
              <a:rPr lang="el-GR" sz="14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-catenin pathway inhibition. 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Figures illustrate that the </a:t>
            </a:r>
            <a:r>
              <a:rPr lang="el-GR" sz="14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-catenin pathway inhibitor FH535, which interferes with </a:t>
            </a:r>
            <a:r>
              <a:rPr lang="el-GR" sz="1400" dirty="0">
                <a:latin typeface="Arial" pitchFamily="34" charset="0"/>
                <a:cs typeface="Arial" pitchFamily="34" charset="0"/>
              </a:rPr>
              <a:t>β-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catenin’s binding to Tcf/Lef, induces an increase in apoptotic sub-G1 cells in a dose-dependent manner in several different lymphoma cell lines from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Lck-Dlx5;Lck-MyrAkt2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mice.</a:t>
            </a:r>
          </a:p>
        </p:txBody>
      </p:sp>
      <p:pic>
        <p:nvPicPr>
          <p:cNvPr id="4" name="Picture 2" descr="C:\Users\ytan\Desktop\Wnt\manuscript 4\Joe-version\Suppl.FH535.tif">
            <a:extLst>
              <a:ext uri="{FF2B5EF4-FFF2-40B4-BE49-F238E27FC236}">
                <a16:creationId xmlns:a16="http://schemas.microsoft.com/office/drawing/2014/main" id="{C997515C-4C7B-FD48-83A6-842E0ACDB2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99209" y="460520"/>
            <a:ext cx="6147297" cy="4582959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8934103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yinfe\Desktop\desktop\Wnt\manuscript 4\SupplFig5.vennPKFRNA.tif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1663700" y="1663700"/>
            <a:ext cx="5817396" cy="2723229"/>
          </a:xfrm>
          <a:prstGeom prst="rect">
            <a:avLst/>
          </a:prstGeom>
          <a:noFill/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E47C39B-B7AA-414E-9734-358A1513FA5B}"/>
              </a:ext>
            </a:extLst>
          </p:cNvPr>
          <p:cNvSpPr/>
          <p:nvPr/>
        </p:nvSpPr>
        <p:spPr>
          <a:xfrm>
            <a:off x="1486696" y="4879340"/>
            <a:ext cx="617220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itchFamily="34" charset="0"/>
                <a:cs typeface="Arial" pitchFamily="34" charset="0"/>
              </a:rPr>
              <a:t>Supplementary Fig. S4A.  Differentially expressed genes in </a:t>
            </a:r>
            <a:r>
              <a:rPr lang="en-US" sz="1600" b="1" i="1" dirty="0">
                <a:latin typeface="Arial" pitchFamily="34" charset="0"/>
                <a:cs typeface="Arial" pitchFamily="34" charset="0"/>
              </a:rPr>
              <a:t>Lck-Dlx5;Lck-MyrAkt2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 lymphoma cells following </a:t>
            </a:r>
            <a:r>
              <a:rPr lang="el-GR" sz="1600" b="1" dirty="0">
                <a:latin typeface="Arial" pitchFamily="34" charset="0"/>
                <a:cs typeface="Arial" pitchFamily="34" charset="0"/>
              </a:rPr>
              <a:t>β-</a:t>
            </a:r>
            <a:r>
              <a:rPr lang="en-US" sz="1600" b="1" dirty="0">
                <a:latin typeface="Arial" pitchFamily="34" charset="0"/>
                <a:cs typeface="Arial" pitchFamily="34" charset="0"/>
              </a:rPr>
              <a:t>catenin inhibition.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Venn diagram depicting genes commonly up- or down-regulated upon </a:t>
            </a:r>
            <a:r>
              <a:rPr lang="el-GR" sz="1600" dirty="0">
                <a:latin typeface="Arial" pitchFamily="34" charset="0"/>
                <a:cs typeface="Arial" pitchFamily="34" charset="0"/>
              </a:rPr>
              <a:t>β-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catenin inhibition in lymphoma cells from three </a:t>
            </a:r>
            <a:r>
              <a:rPr lang="en-US" sz="1600" i="1" dirty="0">
                <a:latin typeface="Arial" pitchFamily="34" charset="0"/>
                <a:cs typeface="Arial" pitchFamily="34" charset="0"/>
              </a:rPr>
              <a:t>Lck-Dlx5;Lck-MyrAkt2 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mice (DP240, DP242, and DP352). 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yinfe\Desktop\desktop\Wnt\manuscript 4\ALLDP-Srebf2-no-TCF.tif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1981200" y="431800"/>
            <a:ext cx="5181600" cy="4425086"/>
          </a:xfrm>
          <a:prstGeom prst="rect">
            <a:avLst/>
          </a:prstGeom>
          <a:noFill/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717E818-2D43-8242-9A9A-E576D56E86DF}"/>
              </a:ext>
            </a:extLst>
          </p:cNvPr>
          <p:cNvSpPr/>
          <p:nvPr/>
        </p:nvSpPr>
        <p:spPr>
          <a:xfrm>
            <a:off x="1346200" y="5026660"/>
            <a:ext cx="64643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4B.  The </a:t>
            </a:r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tenin inhibitor PFK118-310 inhibits Srebf2 and its target genes in the cholesterol synthesis pathway in DP240, DP242, and DP352 lymphoma cells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lmost all major components in the cholesterol synthesis pathway are upregulated. Abbreviations: C1 and C2, two separate controls of each cell line; P1 and P2, two separate PFK118-310-treated cultures of each cell line. Blue, up-regulated genes; red, down-regulated genes.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685800" y="5486400"/>
            <a:ext cx="7772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itchFamily="34" charset="0"/>
              </a:rPr>
              <a:t>Supplementary Fig. S4C.  ChIP-seq analysis revealed that β-catenin/Tcf7 complex binds to the promoters of </a:t>
            </a:r>
            <a:r>
              <a:rPr lang="en-US" sz="1600" b="1" i="1" dirty="0">
                <a:latin typeface="Arial" panose="020B0604020202020204" pitchFamily="34" charset="0"/>
                <a:cs typeface="Arial" pitchFamily="34" charset="0"/>
              </a:rPr>
              <a:t>Lef1</a:t>
            </a:r>
            <a:r>
              <a:rPr lang="en-US" sz="1600" b="1" dirty="0">
                <a:latin typeface="Arial" panose="020B0604020202020204" pitchFamily="34" charset="0"/>
                <a:cs typeface="Arial" pitchFamily="34" charset="0"/>
              </a:rPr>
              <a:t> and </a:t>
            </a:r>
            <a:r>
              <a:rPr lang="en-US" sz="1600" b="1" i="1" dirty="0">
                <a:latin typeface="Arial" panose="020B0604020202020204" pitchFamily="34" charset="0"/>
                <a:cs typeface="Arial" pitchFamily="34" charset="0"/>
              </a:rPr>
              <a:t>Axin2</a:t>
            </a:r>
            <a:r>
              <a:rPr lang="en-US" sz="1600" b="1" dirty="0">
                <a:latin typeface="Arial" panose="020B0604020202020204" pitchFamily="34" charset="0"/>
                <a:cs typeface="Arial" pitchFamily="34" charset="0"/>
              </a:rPr>
              <a:t>. </a:t>
            </a:r>
            <a:r>
              <a:rPr lang="en-US" sz="1600" dirty="0">
                <a:latin typeface="Arial" panose="020B0604020202020204" pitchFamily="34" charset="0"/>
                <a:cs typeface="Arial" pitchFamily="34" charset="0"/>
              </a:rPr>
              <a:t>Both</a:t>
            </a:r>
            <a:r>
              <a:rPr lang="en-US" sz="1600" b="1" dirty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itchFamily="34" charset="0"/>
              </a:rPr>
              <a:t>the</a:t>
            </a:r>
            <a:r>
              <a:rPr lang="en-US" sz="1600" b="1" dirty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itchFamily="34" charset="0"/>
              </a:rPr>
              <a:t>ChIP sample and the Input (negative control) sample are shown.</a:t>
            </a:r>
          </a:p>
        </p:txBody>
      </p:sp>
      <p:pic>
        <p:nvPicPr>
          <p:cNvPr id="2051" name="Picture 3" descr="C:\Users\yinfe\Desktop\desktop\Wnt\manuscript 4\Suppl.ChIP-Lef, Axin2b.tif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630373" y="1143000"/>
            <a:ext cx="8068421" cy="3505200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325573" y="3556337"/>
            <a:ext cx="685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hIP 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</p:spTree>
    <p:extLst>
      <p:ext uri="{BB962C8B-B14F-4D97-AF65-F5344CB8AC3E}">
        <p14:creationId xmlns:p14="http://schemas.microsoft.com/office/powerpoint/2010/main" val="4038565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/>
          <a:srcRect/>
          <a:stretch>
            <a:fillRect/>
          </a:stretch>
        </p:blipFill>
        <p:spPr bwMode="auto">
          <a:xfrm>
            <a:off x="551873" y="886691"/>
            <a:ext cx="2590800" cy="16145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75673" y="2715491"/>
            <a:ext cx="2761311" cy="1689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447473" y="886691"/>
            <a:ext cx="2571262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447473" y="2639291"/>
            <a:ext cx="2630332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6343073" y="886691"/>
            <a:ext cx="2341563" cy="16208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6266873" y="2639291"/>
            <a:ext cx="2743200" cy="1687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Rectangle 12"/>
          <p:cNvSpPr/>
          <p:nvPr/>
        </p:nvSpPr>
        <p:spPr>
          <a:xfrm>
            <a:off x="796636" y="4865251"/>
            <a:ext cx="76200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Supplementary Fig. S4D.  ChIP-seq analysis revealed that the </a:t>
            </a:r>
            <a:r>
              <a:rPr lang="el-GR" sz="1400" b="1" dirty="0">
                <a:solidFill>
                  <a:srgbClr val="000000"/>
                </a:solidFill>
                <a:latin typeface="Arial" panose="020B0604020202020204" pitchFamily="34" charset="0"/>
              </a:rPr>
              <a:t>β-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catenin/Tcf7 complex binds to the promoter/enhancer of </a:t>
            </a:r>
            <a:r>
              <a:rPr lang="en-US" sz="1400" b="1" i="1" dirty="0">
                <a:solidFill>
                  <a:srgbClr val="000000"/>
                </a:solidFill>
                <a:latin typeface="Arial" panose="020B0604020202020204" pitchFamily="34" charset="0"/>
              </a:rPr>
              <a:t>Cdk12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sz="1400" b="1" i="1" dirty="0">
                <a:solidFill>
                  <a:srgbClr val="000000"/>
                </a:solidFill>
                <a:latin typeface="Arial" panose="020B0604020202020204" pitchFamily="34" charset="0"/>
              </a:rPr>
              <a:t>Smc1a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sz="1400" b="1" i="1" dirty="0">
                <a:solidFill>
                  <a:srgbClr val="000000"/>
                </a:solidFill>
                <a:latin typeface="Arial" panose="020B0604020202020204" pitchFamily="34" charset="0"/>
              </a:rPr>
              <a:t>Nf1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sz="1400" b="1" i="1" dirty="0">
                <a:solidFill>
                  <a:srgbClr val="000000"/>
                </a:solidFill>
                <a:latin typeface="Arial" panose="020B0604020202020204" pitchFamily="34" charset="0"/>
              </a:rPr>
              <a:t>Hdac7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sz="1400" b="1" i="1" dirty="0">
                <a:solidFill>
                  <a:srgbClr val="000000"/>
                </a:solidFill>
                <a:latin typeface="Arial" panose="020B0604020202020204" pitchFamily="34" charset="0"/>
              </a:rPr>
              <a:t>Polr1a/Ptcd3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and </a:t>
            </a:r>
            <a:r>
              <a:rPr lang="en-US" sz="1400" b="1" i="1" dirty="0">
                <a:solidFill>
                  <a:srgbClr val="000000"/>
                </a:solidFill>
                <a:latin typeface="Arial" panose="020B0604020202020204" pitchFamily="34" charset="0"/>
              </a:rPr>
              <a:t>Cenpe.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Input DNA served as a negative control. Note that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Cenpe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has been previously used as a positive control promoter for </a:t>
            </a:r>
            <a:r>
              <a:rPr lang="el-GR" sz="1400" dirty="0">
                <a:latin typeface="Arial" panose="020B0604020202020204" pitchFamily="34" charset="0"/>
              </a:rPr>
              <a:t>β-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catenin (PMCID: PMC6014489).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LEF1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Axin2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re known targets of </a:t>
            </a:r>
            <a:r>
              <a:rPr lang="el-GR" sz="1400" dirty="0">
                <a:latin typeface="Arial" pitchFamily="34" charset="0"/>
                <a:cs typeface="Arial" pitchFamily="34" charset="0"/>
              </a:rPr>
              <a:t>β-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catenin/Tcf7 binding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8493" y="1953491"/>
            <a:ext cx="53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hIP 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0785" y="3858491"/>
            <a:ext cx="53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hIP 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</p:spTree>
    <p:extLst>
      <p:ext uri="{BB962C8B-B14F-4D97-AF65-F5344CB8AC3E}">
        <p14:creationId xmlns:p14="http://schemas.microsoft.com/office/powerpoint/2010/main" val="427086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65</TotalTime>
  <Words>1274</Words>
  <Application>Microsoft Macintosh PowerPoint</Application>
  <PresentationFormat>On-screen Show (4:3)</PresentationFormat>
  <Paragraphs>73</Paragraphs>
  <Slides>2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5" baseType="lpstr">
      <vt:lpstr>Arial</vt:lpstr>
      <vt:lpstr>Calibri</vt:lpstr>
      <vt:lpstr>Times New Roman</vt:lpstr>
      <vt:lpstr>Office Theme</vt:lpstr>
      <vt:lpstr>Supplemental Material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C</vt:lpstr>
      <vt:lpstr>D</vt:lpstr>
      <vt:lpstr>Supplementary Table S1  Karyotypic analysis of thymic lymphomas from Lck-Dlx5;Lck-MyrAkt2 mice</vt:lpstr>
      <vt:lpstr>Full List of Author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n, Yin Fei</dc:creator>
  <cp:lastModifiedBy>Microsoft Office User</cp:lastModifiedBy>
  <cp:revision>229</cp:revision>
  <dcterms:created xsi:type="dcterms:W3CDTF">2006-08-16T00:00:00Z</dcterms:created>
  <dcterms:modified xsi:type="dcterms:W3CDTF">2020-08-03T15:41:12Z</dcterms:modified>
</cp:coreProperties>
</file>